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notesMasterIdLst>
    <p:notesMasterId r:id="rId3"/>
  </p:notesMasterIdLst>
  <p:sldIdLst>
    <p:sldId id="309" r:id="rId2"/>
  </p:sldIdLst>
  <p:sldSz cx="12599988" cy="97202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062" userDrawn="1">
          <p15:clr>
            <a:srgbClr val="A4A3A4"/>
          </p15:clr>
        </p15:guide>
        <p15:guide id="2" pos="396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23232"/>
    <a:srgbClr val="808080"/>
    <a:srgbClr val="D4D4D4"/>
    <a:srgbClr val="FFFFFF"/>
    <a:srgbClr val="052DAF"/>
    <a:srgbClr val="7998FB"/>
    <a:srgbClr val="A5D69E"/>
    <a:srgbClr val="96979A"/>
    <a:srgbClr val="606060"/>
    <a:srgbClr val="A0A0A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833" autoAdjust="0"/>
    <p:restoredTop sz="93978" autoAdjust="0"/>
  </p:normalViewPr>
  <p:slideViewPr>
    <p:cSldViewPr snapToGrid="0">
      <p:cViewPr>
        <p:scale>
          <a:sx n="66" d="100"/>
          <a:sy n="66" d="100"/>
        </p:scale>
        <p:origin x="-2742" y="-612"/>
      </p:cViewPr>
      <p:guideLst>
        <p:guide orient="horz" pos="3062"/>
        <p:guide pos="3969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-140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5" Type="http://schemas.microsoft.com/office/2016/11/relationships/changesInfo" Target="changesInfos/changesInfo1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조 원영" userId="ad09e4e21d07ae2d" providerId="LiveId" clId="{8EC55C7C-CBE2-49D3-9A64-A50B03834E8B}"/>
    <pc:docChg chg="modSld">
      <pc:chgData name="조 원영" userId="ad09e4e21d07ae2d" providerId="LiveId" clId="{8EC55C7C-CBE2-49D3-9A64-A50B03834E8B}" dt="2023-01-16T08:49:12.862" v="7" actId="27918"/>
      <pc:docMkLst>
        <pc:docMk/>
      </pc:docMkLst>
      <pc:sldChg chg="addSp modSp mod">
        <pc:chgData name="조 원영" userId="ad09e4e21d07ae2d" providerId="LiveId" clId="{8EC55C7C-CBE2-49D3-9A64-A50B03834E8B}" dt="2023-01-16T08:49:12.862" v="7" actId="27918"/>
        <pc:sldMkLst>
          <pc:docMk/>
          <pc:sldMk cId="619899231" sldId="258"/>
        </pc:sldMkLst>
        <pc:graphicFrameChg chg="add mod">
          <ac:chgData name="조 원영" userId="ad09e4e21d07ae2d" providerId="LiveId" clId="{8EC55C7C-CBE2-49D3-9A64-A50B03834E8B}" dt="2023-01-16T08:48:25.647" v="6" actId="1076"/>
          <ac:graphicFrameMkLst>
            <pc:docMk/>
            <pc:sldMk cId="619899231" sldId="258"/>
            <ac:graphicFrameMk id="22" creationId="{FB830F62-14F8-CD2A-E9CE-8E99020D5335}"/>
          </ac:graphicFrameMkLst>
        </pc:graphicFrameChg>
      </pc:sldChg>
      <pc:sldChg chg="modSp mod">
        <pc:chgData name="조 원영" userId="ad09e4e21d07ae2d" providerId="LiveId" clId="{8EC55C7C-CBE2-49D3-9A64-A50B03834E8B}" dt="2022-12-16T06:02:33.071" v="1" actId="108"/>
        <pc:sldMkLst>
          <pc:docMk/>
          <pc:sldMk cId="3158143627" sldId="261"/>
        </pc:sldMkLst>
        <pc:spChg chg="mod">
          <ac:chgData name="조 원영" userId="ad09e4e21d07ae2d" providerId="LiveId" clId="{8EC55C7C-CBE2-49D3-9A64-A50B03834E8B}" dt="2022-12-16T06:02:33.071" v="1" actId="108"/>
          <ac:spMkLst>
            <pc:docMk/>
            <pc:sldMk cId="3158143627" sldId="261"/>
            <ac:spMk id="4" creationId="{7A7D8094-E21D-352E-B9FD-17A02DA308D5}"/>
          </ac:spMkLst>
        </pc:spChg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DB0E596-1DF1-4836-A988-9FC1BB16948D}" type="datetimeFigureOut">
              <a:rPr lang="ko-KR" altLang="en-US" smtClean="0"/>
              <a:t>2023-05-2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208088" y="685800"/>
            <a:ext cx="44418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4FD3F9D-7004-41CE-AB35-4064D4641CB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186559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1208088" y="685800"/>
            <a:ext cx="4441825" cy="34290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4FD3F9D-7004-41CE-AB35-4064D4641CB4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509940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44999" y="1590794"/>
            <a:ext cx="10709990" cy="3384092"/>
          </a:xfrm>
        </p:spPr>
        <p:txBody>
          <a:bodyPr anchor="b"/>
          <a:lstStyle>
            <a:lvl1pPr algn="ctr">
              <a:defRPr sz="8268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74999" y="5105389"/>
            <a:ext cx="9449991" cy="2346813"/>
          </a:xfrm>
        </p:spPr>
        <p:txBody>
          <a:bodyPr/>
          <a:lstStyle>
            <a:lvl1pPr marL="0" indent="0" algn="ctr">
              <a:buNone/>
              <a:defRPr sz="3307"/>
            </a:lvl1pPr>
            <a:lvl2pPr marL="630022" indent="0" algn="ctr">
              <a:buNone/>
              <a:defRPr sz="2756"/>
            </a:lvl2pPr>
            <a:lvl3pPr marL="1260043" indent="0" algn="ctr">
              <a:buNone/>
              <a:defRPr sz="2480"/>
            </a:lvl3pPr>
            <a:lvl4pPr marL="1890065" indent="0" algn="ctr">
              <a:buNone/>
              <a:defRPr sz="2205"/>
            </a:lvl4pPr>
            <a:lvl5pPr marL="2520086" indent="0" algn="ctr">
              <a:buNone/>
              <a:defRPr sz="2205"/>
            </a:lvl5pPr>
            <a:lvl6pPr marL="3150108" indent="0" algn="ctr">
              <a:buNone/>
              <a:defRPr sz="2205"/>
            </a:lvl6pPr>
            <a:lvl7pPr marL="3780130" indent="0" algn="ctr">
              <a:buNone/>
              <a:defRPr sz="2205"/>
            </a:lvl7pPr>
            <a:lvl8pPr marL="4410151" indent="0" algn="ctr">
              <a:buNone/>
              <a:defRPr sz="2205"/>
            </a:lvl8pPr>
            <a:lvl9pPr marL="5040173" indent="0" algn="ctr">
              <a:buNone/>
              <a:defRPr sz="2205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C05E-DB2C-4875-A3CF-4FE1CDC97EBC}" type="datetimeFigureOut">
              <a:rPr lang="ko-KR" altLang="en-US" smtClean="0"/>
              <a:t>2023-05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9605D-97A7-4407-B888-338F02050A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031254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C05E-DB2C-4875-A3CF-4FE1CDC97EBC}" type="datetimeFigureOut">
              <a:rPr lang="ko-KR" altLang="en-US" smtClean="0"/>
              <a:t>2023-05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9605D-97A7-4407-B888-338F02050A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944906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016867" y="517514"/>
            <a:ext cx="2716872" cy="8237474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66250" y="517514"/>
            <a:ext cx="7993117" cy="8237474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C05E-DB2C-4875-A3CF-4FE1CDC97EBC}" type="datetimeFigureOut">
              <a:rPr lang="ko-KR" altLang="en-US" smtClean="0"/>
              <a:t>2023-05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9605D-97A7-4407-B888-338F02050A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97929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C05E-DB2C-4875-A3CF-4FE1CDC97EBC}" type="datetimeFigureOut">
              <a:rPr lang="ko-KR" altLang="en-US" smtClean="0"/>
              <a:t>2023-05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9605D-97A7-4407-B888-338F02050A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05908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9687" y="2423318"/>
            <a:ext cx="10867490" cy="4043359"/>
          </a:xfrm>
        </p:spPr>
        <p:txBody>
          <a:bodyPr anchor="b"/>
          <a:lstStyle>
            <a:lvl1pPr>
              <a:defRPr sz="8268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9687" y="6504929"/>
            <a:ext cx="10867490" cy="2126307"/>
          </a:xfrm>
        </p:spPr>
        <p:txBody>
          <a:bodyPr/>
          <a:lstStyle>
            <a:lvl1pPr marL="0" indent="0">
              <a:buNone/>
              <a:defRPr sz="3307">
                <a:solidFill>
                  <a:schemeClr val="tx1"/>
                </a:solidFill>
              </a:defRPr>
            </a:lvl1pPr>
            <a:lvl2pPr marL="630022" indent="0">
              <a:buNone/>
              <a:defRPr sz="2756">
                <a:solidFill>
                  <a:schemeClr val="tx1">
                    <a:tint val="75000"/>
                  </a:schemeClr>
                </a:solidFill>
              </a:defRPr>
            </a:lvl2pPr>
            <a:lvl3pPr marL="1260043" indent="0">
              <a:buNone/>
              <a:defRPr sz="2480">
                <a:solidFill>
                  <a:schemeClr val="tx1">
                    <a:tint val="75000"/>
                  </a:schemeClr>
                </a:solidFill>
              </a:defRPr>
            </a:lvl3pPr>
            <a:lvl4pPr marL="1890065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4pPr>
            <a:lvl5pPr marL="2520086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5pPr>
            <a:lvl6pPr marL="3150108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6pPr>
            <a:lvl7pPr marL="3780130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7pPr>
            <a:lvl8pPr marL="4410151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8pPr>
            <a:lvl9pPr marL="5040173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C05E-DB2C-4875-A3CF-4FE1CDC97EBC}" type="datetimeFigureOut">
              <a:rPr lang="ko-KR" altLang="en-US" smtClean="0"/>
              <a:t>2023-05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9605D-97A7-4407-B888-338F02050A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5080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66249" y="2587570"/>
            <a:ext cx="5354995" cy="616741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78744" y="2587570"/>
            <a:ext cx="5354995" cy="616741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C05E-DB2C-4875-A3CF-4FE1CDC97EBC}" type="datetimeFigureOut">
              <a:rPr lang="ko-KR" altLang="en-US" smtClean="0"/>
              <a:t>2023-05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9605D-97A7-4407-B888-338F02050A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844744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517516"/>
            <a:ext cx="10867490" cy="18788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7892" y="2382815"/>
            <a:ext cx="5330385" cy="1167781"/>
          </a:xfrm>
        </p:spPr>
        <p:txBody>
          <a:bodyPr anchor="b"/>
          <a:lstStyle>
            <a:lvl1pPr marL="0" indent="0">
              <a:buNone/>
              <a:defRPr sz="3307" b="1"/>
            </a:lvl1pPr>
            <a:lvl2pPr marL="630022" indent="0">
              <a:buNone/>
              <a:defRPr sz="2756" b="1"/>
            </a:lvl2pPr>
            <a:lvl3pPr marL="1260043" indent="0">
              <a:buNone/>
              <a:defRPr sz="2480" b="1"/>
            </a:lvl3pPr>
            <a:lvl4pPr marL="1890065" indent="0">
              <a:buNone/>
              <a:defRPr sz="2205" b="1"/>
            </a:lvl4pPr>
            <a:lvl5pPr marL="2520086" indent="0">
              <a:buNone/>
              <a:defRPr sz="2205" b="1"/>
            </a:lvl5pPr>
            <a:lvl6pPr marL="3150108" indent="0">
              <a:buNone/>
              <a:defRPr sz="2205" b="1"/>
            </a:lvl6pPr>
            <a:lvl7pPr marL="3780130" indent="0">
              <a:buNone/>
              <a:defRPr sz="2205" b="1"/>
            </a:lvl7pPr>
            <a:lvl8pPr marL="4410151" indent="0">
              <a:buNone/>
              <a:defRPr sz="2205" b="1"/>
            </a:lvl8pPr>
            <a:lvl9pPr marL="5040173" indent="0">
              <a:buNone/>
              <a:defRPr sz="2205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67892" y="3550596"/>
            <a:ext cx="5330385" cy="522239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78745" y="2382815"/>
            <a:ext cx="5356636" cy="1167781"/>
          </a:xfrm>
        </p:spPr>
        <p:txBody>
          <a:bodyPr anchor="b"/>
          <a:lstStyle>
            <a:lvl1pPr marL="0" indent="0">
              <a:buNone/>
              <a:defRPr sz="3307" b="1"/>
            </a:lvl1pPr>
            <a:lvl2pPr marL="630022" indent="0">
              <a:buNone/>
              <a:defRPr sz="2756" b="1"/>
            </a:lvl2pPr>
            <a:lvl3pPr marL="1260043" indent="0">
              <a:buNone/>
              <a:defRPr sz="2480" b="1"/>
            </a:lvl3pPr>
            <a:lvl4pPr marL="1890065" indent="0">
              <a:buNone/>
              <a:defRPr sz="2205" b="1"/>
            </a:lvl4pPr>
            <a:lvl5pPr marL="2520086" indent="0">
              <a:buNone/>
              <a:defRPr sz="2205" b="1"/>
            </a:lvl5pPr>
            <a:lvl6pPr marL="3150108" indent="0">
              <a:buNone/>
              <a:defRPr sz="2205" b="1"/>
            </a:lvl6pPr>
            <a:lvl7pPr marL="3780130" indent="0">
              <a:buNone/>
              <a:defRPr sz="2205" b="1"/>
            </a:lvl7pPr>
            <a:lvl8pPr marL="4410151" indent="0">
              <a:buNone/>
              <a:defRPr sz="2205" b="1"/>
            </a:lvl8pPr>
            <a:lvl9pPr marL="5040173" indent="0">
              <a:buNone/>
              <a:defRPr sz="2205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378745" y="3550596"/>
            <a:ext cx="5356636" cy="522239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C05E-DB2C-4875-A3CF-4FE1CDC97EBC}" type="datetimeFigureOut">
              <a:rPr lang="ko-KR" altLang="en-US" smtClean="0"/>
              <a:t>2023-05-2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9605D-97A7-4407-B888-338F02050A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002786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C05E-DB2C-4875-A3CF-4FE1CDC97EBC}" type="datetimeFigureOut">
              <a:rPr lang="ko-KR" altLang="en-US" smtClean="0"/>
              <a:t>2023-05-2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9605D-97A7-4407-B888-338F02050A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80528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C05E-DB2C-4875-A3CF-4FE1CDC97EBC}" type="datetimeFigureOut">
              <a:rPr lang="ko-KR" altLang="en-US" smtClean="0"/>
              <a:t>2023-05-2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9605D-97A7-4407-B888-338F02050A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91407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648018"/>
            <a:ext cx="4063824" cy="2268061"/>
          </a:xfrm>
        </p:spPr>
        <p:txBody>
          <a:bodyPr anchor="b"/>
          <a:lstStyle>
            <a:lvl1pPr>
              <a:defRPr sz="441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56636" y="1399540"/>
            <a:ext cx="6378744" cy="6907687"/>
          </a:xfrm>
        </p:spPr>
        <p:txBody>
          <a:bodyPr/>
          <a:lstStyle>
            <a:lvl1pPr>
              <a:defRPr sz="4410"/>
            </a:lvl1pPr>
            <a:lvl2pPr>
              <a:defRPr sz="3858"/>
            </a:lvl2pPr>
            <a:lvl3pPr>
              <a:defRPr sz="3307"/>
            </a:lvl3pPr>
            <a:lvl4pPr>
              <a:defRPr sz="2756"/>
            </a:lvl4pPr>
            <a:lvl5pPr>
              <a:defRPr sz="2756"/>
            </a:lvl5pPr>
            <a:lvl6pPr>
              <a:defRPr sz="2756"/>
            </a:lvl6pPr>
            <a:lvl7pPr>
              <a:defRPr sz="2756"/>
            </a:lvl7pPr>
            <a:lvl8pPr>
              <a:defRPr sz="2756"/>
            </a:lvl8pPr>
            <a:lvl9pPr>
              <a:defRPr sz="2756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0" y="2916079"/>
            <a:ext cx="4063824" cy="5402397"/>
          </a:xfrm>
        </p:spPr>
        <p:txBody>
          <a:bodyPr/>
          <a:lstStyle>
            <a:lvl1pPr marL="0" indent="0">
              <a:buNone/>
              <a:defRPr sz="2205"/>
            </a:lvl1pPr>
            <a:lvl2pPr marL="630022" indent="0">
              <a:buNone/>
              <a:defRPr sz="1929"/>
            </a:lvl2pPr>
            <a:lvl3pPr marL="1260043" indent="0">
              <a:buNone/>
              <a:defRPr sz="1654"/>
            </a:lvl3pPr>
            <a:lvl4pPr marL="1890065" indent="0">
              <a:buNone/>
              <a:defRPr sz="1378"/>
            </a:lvl4pPr>
            <a:lvl5pPr marL="2520086" indent="0">
              <a:buNone/>
              <a:defRPr sz="1378"/>
            </a:lvl5pPr>
            <a:lvl6pPr marL="3150108" indent="0">
              <a:buNone/>
              <a:defRPr sz="1378"/>
            </a:lvl6pPr>
            <a:lvl7pPr marL="3780130" indent="0">
              <a:buNone/>
              <a:defRPr sz="1378"/>
            </a:lvl7pPr>
            <a:lvl8pPr marL="4410151" indent="0">
              <a:buNone/>
              <a:defRPr sz="1378"/>
            </a:lvl8pPr>
            <a:lvl9pPr marL="5040173" indent="0">
              <a:buNone/>
              <a:defRPr sz="1378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C05E-DB2C-4875-A3CF-4FE1CDC97EBC}" type="datetimeFigureOut">
              <a:rPr lang="ko-KR" altLang="en-US" smtClean="0"/>
              <a:t>2023-05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9605D-97A7-4407-B888-338F02050A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917739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648018"/>
            <a:ext cx="4063824" cy="2268061"/>
          </a:xfrm>
        </p:spPr>
        <p:txBody>
          <a:bodyPr anchor="b"/>
          <a:lstStyle>
            <a:lvl1pPr>
              <a:defRPr sz="441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356636" y="1399540"/>
            <a:ext cx="6378744" cy="6907687"/>
          </a:xfrm>
        </p:spPr>
        <p:txBody>
          <a:bodyPr anchor="t"/>
          <a:lstStyle>
            <a:lvl1pPr marL="0" indent="0">
              <a:buNone/>
              <a:defRPr sz="4410"/>
            </a:lvl1pPr>
            <a:lvl2pPr marL="630022" indent="0">
              <a:buNone/>
              <a:defRPr sz="3858"/>
            </a:lvl2pPr>
            <a:lvl3pPr marL="1260043" indent="0">
              <a:buNone/>
              <a:defRPr sz="3307"/>
            </a:lvl3pPr>
            <a:lvl4pPr marL="1890065" indent="0">
              <a:buNone/>
              <a:defRPr sz="2756"/>
            </a:lvl4pPr>
            <a:lvl5pPr marL="2520086" indent="0">
              <a:buNone/>
              <a:defRPr sz="2756"/>
            </a:lvl5pPr>
            <a:lvl6pPr marL="3150108" indent="0">
              <a:buNone/>
              <a:defRPr sz="2756"/>
            </a:lvl6pPr>
            <a:lvl7pPr marL="3780130" indent="0">
              <a:buNone/>
              <a:defRPr sz="2756"/>
            </a:lvl7pPr>
            <a:lvl8pPr marL="4410151" indent="0">
              <a:buNone/>
              <a:defRPr sz="2756"/>
            </a:lvl8pPr>
            <a:lvl9pPr marL="5040173" indent="0">
              <a:buNone/>
              <a:defRPr sz="2756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0" y="2916079"/>
            <a:ext cx="4063824" cy="5402397"/>
          </a:xfrm>
        </p:spPr>
        <p:txBody>
          <a:bodyPr/>
          <a:lstStyle>
            <a:lvl1pPr marL="0" indent="0">
              <a:buNone/>
              <a:defRPr sz="2205"/>
            </a:lvl1pPr>
            <a:lvl2pPr marL="630022" indent="0">
              <a:buNone/>
              <a:defRPr sz="1929"/>
            </a:lvl2pPr>
            <a:lvl3pPr marL="1260043" indent="0">
              <a:buNone/>
              <a:defRPr sz="1654"/>
            </a:lvl3pPr>
            <a:lvl4pPr marL="1890065" indent="0">
              <a:buNone/>
              <a:defRPr sz="1378"/>
            </a:lvl4pPr>
            <a:lvl5pPr marL="2520086" indent="0">
              <a:buNone/>
              <a:defRPr sz="1378"/>
            </a:lvl5pPr>
            <a:lvl6pPr marL="3150108" indent="0">
              <a:buNone/>
              <a:defRPr sz="1378"/>
            </a:lvl6pPr>
            <a:lvl7pPr marL="3780130" indent="0">
              <a:buNone/>
              <a:defRPr sz="1378"/>
            </a:lvl7pPr>
            <a:lvl8pPr marL="4410151" indent="0">
              <a:buNone/>
              <a:defRPr sz="1378"/>
            </a:lvl8pPr>
            <a:lvl9pPr marL="5040173" indent="0">
              <a:buNone/>
              <a:defRPr sz="1378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C05E-DB2C-4875-A3CF-4FE1CDC97EBC}" type="datetimeFigureOut">
              <a:rPr lang="ko-KR" altLang="en-US" smtClean="0"/>
              <a:t>2023-05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9605D-97A7-4407-B888-338F02050A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095661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66249" y="517516"/>
            <a:ext cx="10867490" cy="18788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6249" y="2587570"/>
            <a:ext cx="10867490" cy="616741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66249" y="9009246"/>
            <a:ext cx="2834997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B8C05E-DB2C-4875-A3CF-4FE1CDC97EBC}" type="datetimeFigureOut">
              <a:rPr lang="ko-KR" altLang="en-US" smtClean="0"/>
              <a:t>2023-05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73746" y="9009246"/>
            <a:ext cx="4252496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898742" y="9009246"/>
            <a:ext cx="2834997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79605D-97A7-4407-B888-338F02050A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024004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1260043" rtl="0" eaLnBrk="1" latinLnBrk="1" hangingPunct="1">
        <a:lnSpc>
          <a:spcPct val="90000"/>
        </a:lnSpc>
        <a:spcBef>
          <a:spcPct val="0"/>
        </a:spcBef>
        <a:buNone/>
        <a:defRPr sz="606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15011" indent="-315011" algn="l" defTabSz="1260043" rtl="0" eaLnBrk="1" latinLnBrk="1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sz="3858" kern="1200">
          <a:solidFill>
            <a:schemeClr val="tx1"/>
          </a:solidFill>
          <a:latin typeface="+mn-lt"/>
          <a:ea typeface="+mn-ea"/>
          <a:cs typeface="+mn-cs"/>
        </a:defRPr>
      </a:lvl1pPr>
      <a:lvl2pPr marL="945032" indent="-315011" algn="l" defTabSz="1260043" rtl="0" eaLnBrk="1" latinLnBrk="1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2pPr>
      <a:lvl3pPr marL="1575054" indent="-315011" algn="l" defTabSz="1260043" rtl="0" eaLnBrk="1" latinLnBrk="1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3pPr>
      <a:lvl4pPr marL="2205076" indent="-315011" algn="l" defTabSz="1260043" rtl="0" eaLnBrk="1" latinLnBrk="1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4pPr>
      <a:lvl5pPr marL="2835097" indent="-315011" algn="l" defTabSz="1260043" rtl="0" eaLnBrk="1" latinLnBrk="1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5pPr>
      <a:lvl6pPr marL="3465119" indent="-315011" algn="l" defTabSz="1260043" rtl="0" eaLnBrk="1" latinLnBrk="1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6pPr>
      <a:lvl7pPr marL="4095140" indent="-315011" algn="l" defTabSz="1260043" rtl="0" eaLnBrk="1" latinLnBrk="1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7pPr>
      <a:lvl8pPr marL="4725162" indent="-315011" algn="l" defTabSz="1260043" rtl="0" eaLnBrk="1" latinLnBrk="1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8pPr>
      <a:lvl9pPr marL="5355184" indent="-315011" algn="l" defTabSz="1260043" rtl="0" eaLnBrk="1" latinLnBrk="1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60043" rtl="0" eaLnBrk="1" latinLnBrk="1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1pPr>
      <a:lvl2pPr marL="630022" algn="l" defTabSz="1260043" rtl="0" eaLnBrk="1" latinLnBrk="1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2pPr>
      <a:lvl3pPr marL="1260043" algn="l" defTabSz="1260043" rtl="0" eaLnBrk="1" latinLnBrk="1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3pPr>
      <a:lvl4pPr marL="1890065" algn="l" defTabSz="1260043" rtl="0" eaLnBrk="1" latinLnBrk="1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4pPr>
      <a:lvl5pPr marL="2520086" algn="l" defTabSz="1260043" rtl="0" eaLnBrk="1" latinLnBrk="1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5pPr>
      <a:lvl6pPr marL="3150108" algn="l" defTabSz="1260043" rtl="0" eaLnBrk="1" latinLnBrk="1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6pPr>
      <a:lvl7pPr marL="3780130" algn="l" defTabSz="1260043" rtl="0" eaLnBrk="1" latinLnBrk="1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7pPr>
      <a:lvl8pPr marL="4410151" algn="l" defTabSz="1260043" rtl="0" eaLnBrk="1" latinLnBrk="1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8pPr>
      <a:lvl9pPr marL="5040173" algn="l" defTabSz="1260043" rtl="0" eaLnBrk="1" latinLnBrk="1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em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12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5" Type="http://schemas.openxmlformats.org/officeDocument/2006/relationships/image" Target="../media/image1.e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Box 29">
            <a:extLst>
              <a:ext uri="{FF2B5EF4-FFF2-40B4-BE49-F238E27FC236}">
                <a16:creationId xmlns="" xmlns:a16="http://schemas.microsoft.com/office/drawing/2014/main" id="{5F503267-3005-C127-C679-F671EBCB0BDC}"/>
              </a:ext>
            </a:extLst>
          </p:cNvPr>
          <p:cNvSpPr txBox="1"/>
          <p:nvPr/>
        </p:nvSpPr>
        <p:spPr>
          <a:xfrm>
            <a:off x="510576" y="287974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A</a:t>
            </a:r>
            <a:endParaRPr lang="ko-KR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="" xmlns:a16="http://schemas.microsoft.com/office/drawing/2014/main" id="{9480275D-9CA5-491A-A943-92038ED2CFFC}"/>
              </a:ext>
            </a:extLst>
          </p:cNvPr>
          <p:cNvSpPr txBox="1"/>
          <p:nvPr/>
        </p:nvSpPr>
        <p:spPr>
          <a:xfrm>
            <a:off x="3955735" y="2879741"/>
            <a:ext cx="3138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B</a:t>
            </a:r>
            <a:endParaRPr lang="ko-KR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9817413" y="26512"/>
            <a:ext cx="2578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8" name="그룹 47">
            <a:extLst>
              <a:ext uri="{FF2B5EF4-FFF2-40B4-BE49-F238E27FC236}">
                <a16:creationId xmlns="" xmlns:a16="http://schemas.microsoft.com/office/drawing/2014/main" id="{6634A777-903B-E2C5-512F-7AB5B9EE0668}"/>
              </a:ext>
            </a:extLst>
          </p:cNvPr>
          <p:cNvGrpSpPr/>
          <p:nvPr/>
        </p:nvGrpSpPr>
        <p:grpSpPr>
          <a:xfrm>
            <a:off x="731327" y="3170476"/>
            <a:ext cx="3271708" cy="2772316"/>
            <a:chOff x="731327" y="3170476"/>
            <a:chExt cx="3271708" cy="2772316"/>
          </a:xfrm>
        </p:grpSpPr>
        <p:graphicFrame>
          <p:nvGraphicFramePr>
            <p:cNvPr id="12" name="개체 11">
              <a:extLst>
                <a:ext uri="{FF2B5EF4-FFF2-40B4-BE49-F238E27FC236}">
                  <a16:creationId xmlns="" xmlns:a16="http://schemas.microsoft.com/office/drawing/2014/main" id="{101AC913-A405-3B70-A98F-7EC9E974E5E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18865104"/>
                </p:ext>
              </p:extLst>
            </p:nvPr>
          </p:nvGraphicFramePr>
          <p:xfrm>
            <a:off x="1014246" y="3170476"/>
            <a:ext cx="2776734" cy="267265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180" name="Prism 8" r:id="rId4" imgW="2244006" imgH="2160564" progId="Prism8.Document">
                    <p:embed/>
                  </p:oleObj>
                </mc:Choice>
                <mc:Fallback>
                  <p:oleObj name="Prism 8" r:id="rId4" imgW="2244006" imgH="2160564" progId="Prism8.Document">
                    <p:embed/>
                    <p:pic>
                      <p:nvPicPr>
                        <p:cNvPr id="2" name="개체 1">
                          <a:extLst>
                            <a:ext uri="{FF2B5EF4-FFF2-40B4-BE49-F238E27FC236}">
                              <a16:creationId xmlns="" xmlns:a16="http://schemas.microsoft.com/office/drawing/2014/main" id="{7B640B3A-4F5C-BC5D-436B-32DCB9A8110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1014246" y="3170476"/>
                          <a:ext cx="2776734" cy="267265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5" name="TextBox 24">
              <a:extLst>
                <a:ext uri="{FF2B5EF4-FFF2-40B4-BE49-F238E27FC236}">
                  <a16:creationId xmlns="" xmlns:a16="http://schemas.microsoft.com/office/drawing/2014/main" id="{77F6A84D-4F3B-DE95-A0FF-EBFEB0A687E3}"/>
                </a:ext>
              </a:extLst>
            </p:cNvPr>
            <p:cNvSpPr txBox="1"/>
            <p:nvPr/>
          </p:nvSpPr>
          <p:spPr>
            <a:xfrm>
              <a:off x="3180102" y="3459394"/>
              <a:ext cx="39715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Times New Roman" pitchFamily="18" charset="0"/>
                  <a:cs typeface="Times New Roman" pitchFamily="18" charset="0"/>
                </a:rPr>
                <a:t>low</a:t>
              </a:r>
              <a:endParaRPr lang="ko-KR" alt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="" xmlns:a16="http://schemas.microsoft.com/office/drawing/2014/main" id="{B8FE2E42-03C1-70FD-4017-D856DC4020EB}"/>
                </a:ext>
              </a:extLst>
            </p:cNvPr>
            <p:cNvSpPr txBox="1"/>
            <p:nvPr/>
          </p:nvSpPr>
          <p:spPr>
            <a:xfrm>
              <a:off x="3175827" y="3633942"/>
              <a:ext cx="39715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Times New Roman" pitchFamily="18" charset="0"/>
                  <a:cs typeface="Times New Roman" pitchFamily="18" charset="0"/>
                </a:rPr>
                <a:t>high</a:t>
              </a:r>
              <a:endParaRPr lang="ko-KR" alt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" name="직사각형 27">
              <a:extLst>
                <a:ext uri="{FF2B5EF4-FFF2-40B4-BE49-F238E27FC236}">
                  <a16:creationId xmlns="" xmlns:a16="http://schemas.microsoft.com/office/drawing/2014/main" id="{C649C079-70A3-252A-5FDF-0249F6168FF5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118128" y="3517140"/>
              <a:ext cx="108000" cy="108000"/>
            </a:xfrm>
            <a:prstGeom prst="rect">
              <a:avLst/>
            </a:prstGeom>
            <a:solidFill>
              <a:srgbClr val="FB6D6D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9" name="직사각형 28">
              <a:extLst>
                <a:ext uri="{FF2B5EF4-FFF2-40B4-BE49-F238E27FC236}">
                  <a16:creationId xmlns="" xmlns:a16="http://schemas.microsoft.com/office/drawing/2014/main" id="{C412CF48-D9CF-DDC9-60C8-2D178EC31ED3}"/>
                </a:ext>
              </a:extLst>
            </p:cNvPr>
            <p:cNvSpPr>
              <a:spLocks/>
            </p:cNvSpPr>
            <p:nvPr/>
          </p:nvSpPr>
          <p:spPr>
            <a:xfrm>
              <a:off x="3122891" y="3695357"/>
              <a:ext cx="108000" cy="108000"/>
            </a:xfrm>
            <a:prstGeom prst="rect">
              <a:avLst/>
            </a:prstGeom>
            <a:solidFill>
              <a:srgbClr val="A5D69E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31" name="직선 연결선 30">
              <a:extLst>
                <a:ext uri="{FF2B5EF4-FFF2-40B4-BE49-F238E27FC236}">
                  <a16:creationId xmlns="" xmlns:a16="http://schemas.microsoft.com/office/drawing/2014/main" id="{C651D5B5-83A4-3C97-9AD2-374AF1D15DF9}"/>
                </a:ext>
              </a:extLst>
            </p:cNvPr>
            <p:cNvCxnSpPr>
              <a:cxnSpLocks/>
            </p:cNvCxnSpPr>
            <p:nvPr/>
          </p:nvCxnSpPr>
          <p:spPr>
            <a:xfrm>
              <a:off x="3555548" y="3545007"/>
              <a:ext cx="0" cy="25200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>
              <a:extLst>
                <a:ext uri="{FF2B5EF4-FFF2-40B4-BE49-F238E27FC236}">
                  <a16:creationId xmlns="" xmlns:a16="http://schemas.microsoft.com/office/drawing/2014/main" id="{FA29D8E2-5643-328B-B11A-32BB391AC5CD}"/>
                </a:ext>
              </a:extLst>
            </p:cNvPr>
            <p:cNvSpPr txBox="1"/>
            <p:nvPr/>
          </p:nvSpPr>
          <p:spPr>
            <a:xfrm>
              <a:off x="3555559" y="3555591"/>
              <a:ext cx="44747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Times New Roman" pitchFamily="18" charset="0"/>
                  <a:cs typeface="Times New Roman" pitchFamily="18" charset="0"/>
                </a:rPr>
                <a:t>GSH</a:t>
              </a:r>
              <a:endParaRPr lang="ko-KR" alt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" name="TextBox 3">
              <a:extLst>
                <a:ext uri="{FF2B5EF4-FFF2-40B4-BE49-F238E27FC236}">
                  <a16:creationId xmlns="" xmlns:a16="http://schemas.microsoft.com/office/drawing/2014/main" id="{ED3A88E9-6DAD-5EC3-03EA-5619B3DBCE21}"/>
                </a:ext>
              </a:extLst>
            </p:cNvPr>
            <p:cNvSpPr txBox="1"/>
            <p:nvPr/>
          </p:nvSpPr>
          <p:spPr>
            <a:xfrm>
              <a:off x="1718129" y="5385621"/>
              <a:ext cx="6556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oung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="" xmlns:a16="http://schemas.microsoft.com/office/drawing/2014/main" id="{71F7F9E1-179B-DB7F-F927-C9E1352B9E2F}"/>
                </a:ext>
              </a:extLst>
            </p:cNvPr>
            <p:cNvSpPr txBox="1"/>
            <p:nvPr/>
          </p:nvSpPr>
          <p:spPr>
            <a:xfrm>
              <a:off x="2583820" y="5385621"/>
              <a:ext cx="45397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ld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="" xmlns:a16="http://schemas.microsoft.com/office/drawing/2014/main" id="{0182EECD-658C-4450-867F-9D08FA398F8F}"/>
                </a:ext>
              </a:extLst>
            </p:cNvPr>
            <p:cNvSpPr txBox="1"/>
            <p:nvPr/>
          </p:nvSpPr>
          <p:spPr>
            <a:xfrm>
              <a:off x="2076355" y="5635015"/>
              <a:ext cx="70403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DSCs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" name="직선 연결선 12">
              <a:extLst>
                <a:ext uri="{FF2B5EF4-FFF2-40B4-BE49-F238E27FC236}">
                  <a16:creationId xmlns="" xmlns:a16="http://schemas.microsoft.com/office/drawing/2014/main" id="{796865F5-BA02-38B7-4697-D479EEBBFAC2}"/>
                </a:ext>
              </a:extLst>
            </p:cNvPr>
            <p:cNvCxnSpPr>
              <a:cxnSpLocks/>
            </p:cNvCxnSpPr>
            <p:nvPr/>
          </p:nvCxnSpPr>
          <p:spPr>
            <a:xfrm>
              <a:off x="2045944" y="5693398"/>
              <a:ext cx="76486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>
              <a:extLst>
                <a:ext uri="{FF2B5EF4-FFF2-40B4-BE49-F238E27FC236}">
                  <a16:creationId xmlns="" xmlns:a16="http://schemas.microsoft.com/office/drawing/2014/main" id="{B79147AC-CFAB-EAC9-8585-B5188B8EAFE3}"/>
                </a:ext>
              </a:extLst>
            </p:cNvPr>
            <p:cNvSpPr txBox="1"/>
            <p:nvPr/>
          </p:nvSpPr>
          <p:spPr>
            <a:xfrm rot="16200000">
              <a:off x="439420" y="4186125"/>
              <a:ext cx="89159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 of total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2" name="그룹 51">
            <a:extLst>
              <a:ext uri="{FF2B5EF4-FFF2-40B4-BE49-F238E27FC236}">
                <a16:creationId xmlns="" xmlns:a16="http://schemas.microsoft.com/office/drawing/2014/main" id="{1DD37BD5-F165-1479-F0F3-9ADF5CA58F09}"/>
              </a:ext>
            </a:extLst>
          </p:cNvPr>
          <p:cNvGrpSpPr/>
          <p:nvPr/>
        </p:nvGrpSpPr>
        <p:grpSpPr>
          <a:xfrm>
            <a:off x="4082246" y="3010343"/>
            <a:ext cx="8376866" cy="2974035"/>
            <a:chOff x="4082246" y="3010343"/>
            <a:chExt cx="8376866" cy="2974035"/>
          </a:xfrm>
        </p:grpSpPr>
        <p:graphicFrame>
          <p:nvGraphicFramePr>
            <p:cNvPr id="2" name="개체 1">
              <a:extLst>
                <a:ext uri="{FF2B5EF4-FFF2-40B4-BE49-F238E27FC236}">
                  <a16:creationId xmlns="" xmlns:a16="http://schemas.microsoft.com/office/drawing/2014/main" id="{5E21E5B3-E9F5-8BAB-E334-6A4D5A1322A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08657279"/>
                </p:ext>
              </p:extLst>
            </p:nvPr>
          </p:nvGraphicFramePr>
          <p:xfrm>
            <a:off x="10082625" y="3054350"/>
            <a:ext cx="2376487" cy="28495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181" name="Prism 8" r:id="rId6" imgW="1667788" imgH="2001736" progId="Prism8.Document">
                    <p:embed/>
                  </p:oleObj>
                </mc:Choice>
                <mc:Fallback>
                  <p:oleObj name="Prism 8" r:id="rId6" imgW="1667788" imgH="2001736" progId="Prism8.Document">
                    <p:embed/>
                    <p:pic>
                      <p:nvPicPr>
                        <p:cNvPr id="8" name="개체 7">
                          <a:extLst>
                            <a:ext uri="{FF2B5EF4-FFF2-40B4-BE49-F238E27FC236}">
                              <a16:creationId xmlns="" xmlns:a16="http://schemas.microsoft.com/office/drawing/2014/main" id="{9B5A51FC-F66E-F047-7EDB-FB5C6BACEAD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10082625" y="3054350"/>
                          <a:ext cx="2376487" cy="28495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" name="개체 2">
              <a:extLst>
                <a:ext uri="{FF2B5EF4-FFF2-40B4-BE49-F238E27FC236}">
                  <a16:creationId xmlns="" xmlns:a16="http://schemas.microsoft.com/office/drawing/2014/main" id="{DFBB5A8D-BA4A-35E0-8E7D-ED4301DE097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76986236"/>
                </p:ext>
              </p:extLst>
            </p:nvPr>
          </p:nvGraphicFramePr>
          <p:xfrm>
            <a:off x="8233187" y="3055938"/>
            <a:ext cx="2376488" cy="28511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182" name="Prism 8" r:id="rId8" imgW="1667788" imgH="2001736" progId="Prism8.Document">
                    <p:embed/>
                  </p:oleObj>
                </mc:Choice>
                <mc:Fallback>
                  <p:oleObj name="Prism 8" r:id="rId8" imgW="1667788" imgH="2001736" progId="Prism8.Document">
                    <p:embed/>
                    <p:pic>
                      <p:nvPicPr>
                        <p:cNvPr id="11" name="개체 10">
                          <a:extLst>
                            <a:ext uri="{FF2B5EF4-FFF2-40B4-BE49-F238E27FC236}">
                              <a16:creationId xmlns="" xmlns:a16="http://schemas.microsoft.com/office/drawing/2014/main" id="{5DE56991-451C-13FD-B2FD-2A4565D5D24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8233187" y="3055938"/>
                          <a:ext cx="2376488" cy="28511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개체 5">
              <a:extLst>
                <a:ext uri="{FF2B5EF4-FFF2-40B4-BE49-F238E27FC236}">
                  <a16:creationId xmlns="" xmlns:a16="http://schemas.microsoft.com/office/drawing/2014/main" id="{BEF09D53-DB8C-66B2-B35A-27C696908F4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71345618"/>
                </p:ext>
              </p:extLst>
            </p:nvPr>
          </p:nvGraphicFramePr>
          <p:xfrm>
            <a:off x="4526375" y="3048000"/>
            <a:ext cx="2373312" cy="28495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183" name="Prism 8" r:id="rId10" imgW="1667788" imgH="2001736" progId="Prism8.Document">
                    <p:embed/>
                  </p:oleObj>
                </mc:Choice>
                <mc:Fallback>
                  <p:oleObj name="Prism 8" r:id="rId10" imgW="1667788" imgH="2001736" progId="Prism8.Document">
                    <p:embed/>
                    <p:pic>
                      <p:nvPicPr>
                        <p:cNvPr id="2" name="개체 1">
                          <a:extLst>
                            <a:ext uri="{FF2B5EF4-FFF2-40B4-BE49-F238E27FC236}">
                              <a16:creationId xmlns="" xmlns:a16="http://schemas.microsoft.com/office/drawing/2014/main" id="{65812858-B555-2BF4-2B05-AC16311256E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4526375" y="3048000"/>
                          <a:ext cx="2373312" cy="28495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개체 6">
              <a:extLst>
                <a:ext uri="{FF2B5EF4-FFF2-40B4-BE49-F238E27FC236}">
                  <a16:creationId xmlns="" xmlns:a16="http://schemas.microsoft.com/office/drawing/2014/main" id="{FE973E09-20CF-1092-C48C-4DC819471B2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38106613"/>
                </p:ext>
              </p:extLst>
            </p:nvPr>
          </p:nvGraphicFramePr>
          <p:xfrm>
            <a:off x="6398037" y="3054350"/>
            <a:ext cx="2376488" cy="28495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184" name="Prism 8" r:id="rId12" imgW="1667788" imgH="2001736" progId="Prism8.Document">
                    <p:embed/>
                  </p:oleObj>
                </mc:Choice>
                <mc:Fallback>
                  <p:oleObj name="Prism 8" r:id="rId12" imgW="1667788" imgH="2001736" progId="Prism8.Document">
                    <p:embed/>
                    <p:pic>
                      <p:nvPicPr>
                        <p:cNvPr id="3" name="개체 2">
                          <a:extLst>
                            <a:ext uri="{FF2B5EF4-FFF2-40B4-BE49-F238E27FC236}">
                              <a16:creationId xmlns="" xmlns:a16="http://schemas.microsoft.com/office/drawing/2014/main" id="{91D18B22-4FED-9979-BB5D-A6B1BE813EA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6398037" y="3054350"/>
                          <a:ext cx="2376488" cy="28495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5" name="직선 연결선 4">
              <a:extLst>
                <a:ext uri="{FF2B5EF4-FFF2-40B4-BE49-F238E27FC236}">
                  <a16:creationId xmlns="" xmlns:a16="http://schemas.microsoft.com/office/drawing/2014/main" id="{3EB63C9E-695B-8E58-9B35-E35A4568709C}"/>
                </a:ext>
              </a:extLst>
            </p:cNvPr>
            <p:cNvCxnSpPr>
              <a:cxnSpLocks/>
            </p:cNvCxnSpPr>
            <p:nvPr/>
          </p:nvCxnSpPr>
          <p:spPr>
            <a:xfrm>
              <a:off x="5444075" y="5687789"/>
              <a:ext cx="609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7">
              <a:extLst>
                <a:ext uri="{FF2B5EF4-FFF2-40B4-BE49-F238E27FC236}">
                  <a16:creationId xmlns="" xmlns:a16="http://schemas.microsoft.com/office/drawing/2014/main" id="{8E83E86D-C33C-CE90-89BF-8C83346A7EE3}"/>
                </a:ext>
              </a:extLst>
            </p:cNvPr>
            <p:cNvSpPr txBox="1"/>
            <p:nvPr/>
          </p:nvSpPr>
          <p:spPr>
            <a:xfrm>
              <a:off x="7953557" y="5676601"/>
              <a:ext cx="10740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itchFamily="18" charset="0"/>
                  <a:cs typeface="Times New Roman" pitchFamily="18" charset="0"/>
                </a:rPr>
                <a:t>SDSCs</a:t>
              </a:r>
              <a:endParaRPr lang="ko-KR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="" xmlns:a16="http://schemas.microsoft.com/office/drawing/2014/main" id="{C992BFD8-AC50-F8ED-1563-31B4B69E56C7}"/>
                </a:ext>
              </a:extLst>
            </p:cNvPr>
            <p:cNvSpPr txBox="1"/>
            <p:nvPr/>
          </p:nvSpPr>
          <p:spPr>
            <a:xfrm>
              <a:off x="5391350" y="3016587"/>
              <a:ext cx="6335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CT4</a:t>
              </a:r>
              <a:endParaRPr lang="ko-KR" alt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="" xmlns:a16="http://schemas.microsoft.com/office/drawing/2014/main" id="{1262E69C-119F-73A2-8E44-D6BA55DC7167}"/>
                </a:ext>
              </a:extLst>
            </p:cNvPr>
            <p:cNvSpPr txBox="1"/>
            <p:nvPr/>
          </p:nvSpPr>
          <p:spPr>
            <a:xfrm>
              <a:off x="7308506" y="3016586"/>
              <a:ext cx="6030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OX2</a:t>
              </a:r>
              <a:endParaRPr lang="ko-KR" alt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="" xmlns:a16="http://schemas.microsoft.com/office/drawing/2014/main" id="{0ACDFCA7-B17A-F5E4-A3BD-1A8F31D4AE19}"/>
                </a:ext>
              </a:extLst>
            </p:cNvPr>
            <p:cNvSpPr txBox="1"/>
            <p:nvPr/>
          </p:nvSpPr>
          <p:spPr>
            <a:xfrm>
              <a:off x="9049929" y="3050032"/>
              <a:ext cx="7328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XCR4</a:t>
              </a:r>
              <a:endParaRPr lang="ko-KR" alt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="" xmlns:a16="http://schemas.microsoft.com/office/drawing/2014/main" id="{E19D1313-4CD0-DFD8-1D40-69CE6C10B1FA}"/>
                </a:ext>
              </a:extLst>
            </p:cNvPr>
            <p:cNvSpPr txBox="1"/>
            <p:nvPr/>
          </p:nvSpPr>
          <p:spPr>
            <a:xfrm>
              <a:off x="10930611" y="3010343"/>
              <a:ext cx="62228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MET</a:t>
              </a:r>
              <a:endParaRPr lang="ko-KR" alt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="" xmlns:a16="http://schemas.microsoft.com/office/drawing/2014/main" id="{40946096-C1CA-8A0A-1F6B-A1F296B50700}"/>
                </a:ext>
              </a:extLst>
            </p:cNvPr>
            <p:cNvSpPr txBox="1"/>
            <p:nvPr/>
          </p:nvSpPr>
          <p:spPr>
            <a:xfrm rot="16200000">
              <a:off x="3442135" y="4165140"/>
              <a:ext cx="1803442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mRNA levels</a:t>
              </a:r>
            </a:p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fold change)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="" xmlns:a16="http://schemas.microsoft.com/office/drawing/2014/main" id="{758C1870-3605-A09A-2663-831995616780}"/>
                </a:ext>
              </a:extLst>
            </p:cNvPr>
            <p:cNvSpPr txBox="1"/>
            <p:nvPr/>
          </p:nvSpPr>
          <p:spPr>
            <a:xfrm>
              <a:off x="5116260" y="5382215"/>
              <a:ext cx="6556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oung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TextBox 32">
              <a:extLst>
                <a:ext uri="{FF2B5EF4-FFF2-40B4-BE49-F238E27FC236}">
                  <a16:creationId xmlns="" xmlns:a16="http://schemas.microsoft.com/office/drawing/2014/main" id="{8723CE4A-D2C6-0659-F224-0262078474BE}"/>
                </a:ext>
              </a:extLst>
            </p:cNvPr>
            <p:cNvSpPr txBox="1"/>
            <p:nvPr/>
          </p:nvSpPr>
          <p:spPr>
            <a:xfrm>
              <a:off x="5760289" y="5382214"/>
              <a:ext cx="45397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ld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="" xmlns:a16="http://schemas.microsoft.com/office/drawing/2014/main" id="{188D2441-55EB-39A9-7D12-8335F65B1F93}"/>
                </a:ext>
              </a:extLst>
            </p:cNvPr>
            <p:cNvSpPr txBox="1"/>
            <p:nvPr/>
          </p:nvSpPr>
          <p:spPr>
            <a:xfrm>
              <a:off x="6987646" y="5379663"/>
              <a:ext cx="6556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oung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="" xmlns:a16="http://schemas.microsoft.com/office/drawing/2014/main" id="{9F8CE5A9-BB33-B9EA-C302-27C0292EE1B5}"/>
                </a:ext>
              </a:extLst>
            </p:cNvPr>
            <p:cNvSpPr txBox="1"/>
            <p:nvPr/>
          </p:nvSpPr>
          <p:spPr>
            <a:xfrm>
              <a:off x="7631675" y="5379662"/>
              <a:ext cx="45397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ld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TextBox 41">
              <a:extLst>
                <a:ext uri="{FF2B5EF4-FFF2-40B4-BE49-F238E27FC236}">
                  <a16:creationId xmlns="" xmlns:a16="http://schemas.microsoft.com/office/drawing/2014/main" id="{DBF94BED-AFB7-E560-C571-739A5B870F0D}"/>
                </a:ext>
              </a:extLst>
            </p:cNvPr>
            <p:cNvSpPr txBox="1"/>
            <p:nvPr/>
          </p:nvSpPr>
          <p:spPr>
            <a:xfrm>
              <a:off x="8822796" y="5386636"/>
              <a:ext cx="6556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oung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TextBox 42">
              <a:extLst>
                <a:ext uri="{FF2B5EF4-FFF2-40B4-BE49-F238E27FC236}">
                  <a16:creationId xmlns="" xmlns:a16="http://schemas.microsoft.com/office/drawing/2014/main" id="{34A02AAD-F64B-51E9-7FC9-1A9C90E02639}"/>
                </a:ext>
              </a:extLst>
            </p:cNvPr>
            <p:cNvSpPr txBox="1"/>
            <p:nvPr/>
          </p:nvSpPr>
          <p:spPr>
            <a:xfrm>
              <a:off x="9466825" y="5386635"/>
              <a:ext cx="45397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ld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="" xmlns:a16="http://schemas.microsoft.com/office/drawing/2014/main" id="{A2421637-1946-70C5-85B6-50C61F8214E2}"/>
                </a:ext>
              </a:extLst>
            </p:cNvPr>
            <p:cNvSpPr txBox="1"/>
            <p:nvPr/>
          </p:nvSpPr>
          <p:spPr>
            <a:xfrm>
              <a:off x="10670990" y="5390899"/>
              <a:ext cx="6556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oung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="" xmlns:a16="http://schemas.microsoft.com/office/drawing/2014/main" id="{51EEE273-1D02-5FF4-7B14-EFF221C2043D}"/>
                </a:ext>
              </a:extLst>
            </p:cNvPr>
            <p:cNvSpPr txBox="1"/>
            <p:nvPr/>
          </p:nvSpPr>
          <p:spPr>
            <a:xfrm>
              <a:off x="11315019" y="5390898"/>
              <a:ext cx="45397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ld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570702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55125</TotalTime>
  <Words>35</Words>
  <Application>Microsoft Office PowerPoint</Application>
  <PresentationFormat>Custom</PresentationFormat>
  <Paragraphs>26</Paragraphs>
  <Slides>1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테마</vt:lpstr>
      <vt:lpstr>Prism 8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원영</dc:creator>
  <cp:lastModifiedBy>E738677</cp:lastModifiedBy>
  <cp:revision>457</cp:revision>
  <dcterms:created xsi:type="dcterms:W3CDTF">2022-11-22T20:42:01Z</dcterms:created>
  <dcterms:modified xsi:type="dcterms:W3CDTF">2023-05-24T16:40:55Z</dcterms:modified>
</cp:coreProperties>
</file>